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527777777777746E-2"/>
          <c:y val="0.17171296296296296"/>
          <c:w val="0.82494444444444448"/>
          <c:h val="0.72088764946048411"/>
        </c:manualLayout>
      </c:layout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J$2:$J$32</c:f>
              <c:numCache>
                <c:formatCode>m/d/yyyy</c:formatCode>
                <c:ptCount val="31"/>
                <c:pt idx="0">
                  <c:v>32142</c:v>
                </c:pt>
                <c:pt idx="1">
                  <c:v>32508</c:v>
                </c:pt>
                <c:pt idx="2">
                  <c:v>32873</c:v>
                </c:pt>
                <c:pt idx="3">
                  <c:v>33238</c:v>
                </c:pt>
                <c:pt idx="4">
                  <c:v>33603</c:v>
                </c:pt>
                <c:pt idx="5">
                  <c:v>33969</c:v>
                </c:pt>
                <c:pt idx="6">
                  <c:v>34334</c:v>
                </c:pt>
                <c:pt idx="7">
                  <c:v>34699</c:v>
                </c:pt>
                <c:pt idx="8">
                  <c:v>35064</c:v>
                </c:pt>
                <c:pt idx="9">
                  <c:v>35430</c:v>
                </c:pt>
                <c:pt idx="10">
                  <c:v>35795</c:v>
                </c:pt>
                <c:pt idx="11">
                  <c:v>36160</c:v>
                </c:pt>
                <c:pt idx="12">
                  <c:v>36525</c:v>
                </c:pt>
                <c:pt idx="13">
                  <c:v>36891</c:v>
                </c:pt>
                <c:pt idx="14">
                  <c:v>37256</c:v>
                </c:pt>
                <c:pt idx="15">
                  <c:v>37621</c:v>
                </c:pt>
                <c:pt idx="16">
                  <c:v>37986</c:v>
                </c:pt>
                <c:pt idx="17">
                  <c:v>38352</c:v>
                </c:pt>
                <c:pt idx="18">
                  <c:v>38717</c:v>
                </c:pt>
                <c:pt idx="19">
                  <c:v>39082</c:v>
                </c:pt>
                <c:pt idx="20">
                  <c:v>39447</c:v>
                </c:pt>
                <c:pt idx="21">
                  <c:v>39813</c:v>
                </c:pt>
                <c:pt idx="22">
                  <c:v>40178</c:v>
                </c:pt>
                <c:pt idx="23">
                  <c:v>40543</c:v>
                </c:pt>
                <c:pt idx="24">
                  <c:v>40908</c:v>
                </c:pt>
                <c:pt idx="25">
                  <c:v>41274</c:v>
                </c:pt>
                <c:pt idx="26">
                  <c:v>41639</c:v>
                </c:pt>
                <c:pt idx="27">
                  <c:v>42004</c:v>
                </c:pt>
                <c:pt idx="28">
                  <c:v>42369</c:v>
                </c:pt>
                <c:pt idx="29">
                  <c:v>42735</c:v>
                </c:pt>
                <c:pt idx="30">
                  <c:v>43100</c:v>
                </c:pt>
              </c:numCache>
            </c:numRef>
          </c:xVal>
          <c:yVal>
            <c:numRef>
              <c:f>Sheet1!$K$2:$K$32</c:f>
              <c:numCache>
                <c:formatCode>General</c:formatCode>
                <c:ptCount val="31"/>
                <c:pt idx="0">
                  <c:v>7.3076920000000003</c:v>
                </c:pt>
                <c:pt idx="1">
                  <c:v>23.243243</c:v>
                </c:pt>
                <c:pt idx="2">
                  <c:v>10.183044000000001</c:v>
                </c:pt>
                <c:pt idx="3">
                  <c:v>14.286899</c:v>
                </c:pt>
                <c:pt idx="4">
                  <c:v>17.326121000000001</c:v>
                </c:pt>
                <c:pt idx="5">
                  <c:v>15.933147999999999</c:v>
                </c:pt>
                <c:pt idx="6">
                  <c:v>15.737178999999999</c:v>
                </c:pt>
                <c:pt idx="7">
                  <c:v>17.042334</c:v>
                </c:pt>
                <c:pt idx="8">
                  <c:v>18.374383999999999</c:v>
                </c:pt>
                <c:pt idx="9">
                  <c:v>20.238341999999999</c:v>
                </c:pt>
                <c:pt idx="10">
                  <c:v>19.628513999999999</c:v>
                </c:pt>
                <c:pt idx="11">
                  <c:v>18.940270000000002</c:v>
                </c:pt>
                <c:pt idx="12">
                  <c:v>17.145505</c:v>
                </c:pt>
                <c:pt idx="13">
                  <c:v>18.878416999999999</c:v>
                </c:pt>
                <c:pt idx="14">
                  <c:v>18.668246</c:v>
                </c:pt>
                <c:pt idx="15">
                  <c:v>18.433202000000001</c:v>
                </c:pt>
                <c:pt idx="16">
                  <c:v>21.490385</c:v>
                </c:pt>
                <c:pt idx="17">
                  <c:v>20.773012000000001</c:v>
                </c:pt>
                <c:pt idx="18">
                  <c:v>22.421488</c:v>
                </c:pt>
                <c:pt idx="19">
                  <c:v>24.981549999999999</c:v>
                </c:pt>
                <c:pt idx="20">
                  <c:v>23.151326000000001</c:v>
                </c:pt>
                <c:pt idx="21">
                  <c:v>23.099105999999999</c:v>
                </c:pt>
                <c:pt idx="22">
                  <c:v>26.123816000000001</c:v>
                </c:pt>
                <c:pt idx="23">
                  <c:v>25.316092000000001</c:v>
                </c:pt>
                <c:pt idx="24">
                  <c:v>26.265772999999999</c:v>
                </c:pt>
                <c:pt idx="25">
                  <c:v>26.348279000000002</c:v>
                </c:pt>
                <c:pt idx="26">
                  <c:v>28.224409000000001</c:v>
                </c:pt>
                <c:pt idx="27">
                  <c:v>30.647482</c:v>
                </c:pt>
                <c:pt idx="28">
                  <c:v>37.707999999999998</c:v>
                </c:pt>
                <c:pt idx="29">
                  <c:v>33.136324999999999</c:v>
                </c:pt>
                <c:pt idx="30">
                  <c:v>31.6092939999999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703-432F-87A7-7C4A352E5FA9}"/>
            </c:ext>
          </c:extLst>
        </c:ser>
        <c:ser>
          <c:idx val="1"/>
          <c:order val="1"/>
          <c:tx>
            <c:v>forecast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1!$J$23:$J$32</c:f>
              <c:numCache>
                <c:formatCode>m/d/yyyy</c:formatCode>
                <c:ptCount val="10"/>
                <c:pt idx="0">
                  <c:v>39813</c:v>
                </c:pt>
                <c:pt idx="1">
                  <c:v>40178</c:v>
                </c:pt>
                <c:pt idx="2">
                  <c:v>40543</c:v>
                </c:pt>
                <c:pt idx="3">
                  <c:v>40908</c:v>
                </c:pt>
                <c:pt idx="4">
                  <c:v>41274</c:v>
                </c:pt>
                <c:pt idx="5">
                  <c:v>41639</c:v>
                </c:pt>
                <c:pt idx="6">
                  <c:v>42004</c:v>
                </c:pt>
                <c:pt idx="7">
                  <c:v>42369</c:v>
                </c:pt>
                <c:pt idx="8">
                  <c:v>42735</c:v>
                </c:pt>
                <c:pt idx="9">
                  <c:v>43100</c:v>
                </c:pt>
              </c:numCache>
            </c:numRef>
          </c:xVal>
          <c:yVal>
            <c:numRef>
              <c:f>Sheet1!$M$23:$M$32</c:f>
              <c:numCache>
                <c:formatCode>General</c:formatCode>
                <c:ptCount val="10"/>
                <c:pt idx="0">
                  <c:v>25.376940000000001</c:v>
                </c:pt>
                <c:pt idx="1">
                  <c:v>24.985569999999999</c:v>
                </c:pt>
                <c:pt idx="2">
                  <c:v>26.734749999999998</c:v>
                </c:pt>
                <c:pt idx="3">
                  <c:v>26.819330000000001</c:v>
                </c:pt>
                <c:pt idx="4">
                  <c:v>28.283829999999998</c:v>
                </c:pt>
                <c:pt idx="5">
                  <c:v>28.694019999999998</c:v>
                </c:pt>
                <c:pt idx="6">
                  <c:v>29.998360000000002</c:v>
                </c:pt>
                <c:pt idx="7">
                  <c:v>30.639690000000002</c:v>
                </c:pt>
                <c:pt idx="8">
                  <c:v>31.865159999999999</c:v>
                </c:pt>
                <c:pt idx="9">
                  <c:v>32.67880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703-432F-87A7-7C4A352E5FA9}"/>
            </c:ext>
          </c:extLst>
        </c:ser>
        <c:ser>
          <c:idx val="2"/>
          <c:order val="2"/>
          <c:tx>
            <c:v>forecast_holt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1!$J$23:$J$32</c:f>
              <c:numCache>
                <c:formatCode>m/d/yyyy</c:formatCode>
                <c:ptCount val="10"/>
                <c:pt idx="0">
                  <c:v>39813</c:v>
                </c:pt>
                <c:pt idx="1">
                  <c:v>40178</c:v>
                </c:pt>
                <c:pt idx="2">
                  <c:v>40543</c:v>
                </c:pt>
                <c:pt idx="3">
                  <c:v>40908</c:v>
                </c:pt>
                <c:pt idx="4">
                  <c:v>41274</c:v>
                </c:pt>
                <c:pt idx="5">
                  <c:v>41639</c:v>
                </c:pt>
                <c:pt idx="6">
                  <c:v>42004</c:v>
                </c:pt>
                <c:pt idx="7">
                  <c:v>42369</c:v>
                </c:pt>
                <c:pt idx="8">
                  <c:v>42735</c:v>
                </c:pt>
                <c:pt idx="9">
                  <c:v>43100</c:v>
                </c:pt>
              </c:numCache>
            </c:numRef>
          </c:xVal>
          <c:yVal>
            <c:numRef>
              <c:f>Sheet1!$S$23:$S$32</c:f>
              <c:numCache>
                <c:formatCode>General</c:formatCode>
                <c:ptCount val="10"/>
                <c:pt idx="0">
                  <c:v>23.92285</c:v>
                </c:pt>
                <c:pt idx="1">
                  <c:v>24.447990000000001</c:v>
                </c:pt>
                <c:pt idx="2">
                  <c:v>24.973130000000001</c:v>
                </c:pt>
                <c:pt idx="3">
                  <c:v>25.498270000000002</c:v>
                </c:pt>
                <c:pt idx="4">
                  <c:v>26.023409999999998</c:v>
                </c:pt>
                <c:pt idx="5">
                  <c:v>26.548549999999999</c:v>
                </c:pt>
                <c:pt idx="6">
                  <c:v>27.073689999999999</c:v>
                </c:pt>
                <c:pt idx="7">
                  <c:v>27.59883</c:v>
                </c:pt>
                <c:pt idx="8">
                  <c:v>28.12397</c:v>
                </c:pt>
                <c:pt idx="9">
                  <c:v>28.649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703-432F-87A7-7C4A352E5F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70097535"/>
        <c:axId val="1170414399"/>
      </c:scatterChart>
      <c:valAx>
        <c:axId val="1170097535"/>
        <c:scaling>
          <c:orientation val="minMax"/>
          <c:min val="3000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m/d/yyyy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0414399"/>
        <c:crosses val="autoZero"/>
        <c:crossBetween val="midCat"/>
      </c:valAx>
      <c:valAx>
        <c:axId val="11704143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0097535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Sheet1!$K$23:$K$32</c:f>
              <c:numCache>
                <c:formatCode>General</c:formatCode>
                <c:ptCount val="10"/>
                <c:pt idx="0">
                  <c:v>23.099105999999999</c:v>
                </c:pt>
                <c:pt idx="1">
                  <c:v>26.123816000000001</c:v>
                </c:pt>
                <c:pt idx="2">
                  <c:v>25.316092000000001</c:v>
                </c:pt>
                <c:pt idx="3">
                  <c:v>26.265772999999999</c:v>
                </c:pt>
                <c:pt idx="4">
                  <c:v>26.348279000000002</c:v>
                </c:pt>
                <c:pt idx="5">
                  <c:v>28.224409000000001</c:v>
                </c:pt>
                <c:pt idx="6">
                  <c:v>30.647482</c:v>
                </c:pt>
                <c:pt idx="7">
                  <c:v>37.707999999999998</c:v>
                </c:pt>
                <c:pt idx="8">
                  <c:v>33.136324999999999</c:v>
                </c:pt>
                <c:pt idx="9">
                  <c:v>31.609293999999998</c:v>
                </c:pt>
              </c:numCache>
            </c:numRef>
          </c:xVal>
          <c:yVal>
            <c:numRef>
              <c:f>Sheet1!$M$23:$M$32</c:f>
              <c:numCache>
                <c:formatCode>General</c:formatCode>
                <c:ptCount val="10"/>
                <c:pt idx="0">
                  <c:v>25.376940000000001</c:v>
                </c:pt>
                <c:pt idx="1">
                  <c:v>24.985569999999999</c:v>
                </c:pt>
                <c:pt idx="2">
                  <c:v>26.734749999999998</c:v>
                </c:pt>
                <c:pt idx="3">
                  <c:v>26.819330000000001</c:v>
                </c:pt>
                <c:pt idx="4">
                  <c:v>28.283829999999998</c:v>
                </c:pt>
                <c:pt idx="5">
                  <c:v>28.694019999999998</c:v>
                </c:pt>
                <c:pt idx="6">
                  <c:v>29.998360000000002</c:v>
                </c:pt>
                <c:pt idx="7">
                  <c:v>30.639690000000002</c:v>
                </c:pt>
                <c:pt idx="8">
                  <c:v>31.865159999999999</c:v>
                </c:pt>
                <c:pt idx="9">
                  <c:v>32.67880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1121-41B1-9041-956B5A71DC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88253279"/>
        <c:axId val="921276639"/>
      </c:scatterChart>
      <c:valAx>
        <c:axId val="1088253279"/>
        <c:scaling>
          <c:orientation val="minMax"/>
          <c:min val="2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t-EE"/>
                  <a:t>Forecasted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21276639"/>
        <c:crosses val="autoZero"/>
        <c:crossBetween val="midCat"/>
      </c:valAx>
      <c:valAx>
        <c:axId val="921276639"/>
        <c:scaling>
          <c:orientation val="minMax"/>
          <c:min val="2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t-EE"/>
                  <a:t>Observed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82532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Sheet1!$K$23:$K$32</c:f>
              <c:numCache>
                <c:formatCode>General</c:formatCode>
                <c:ptCount val="10"/>
                <c:pt idx="0">
                  <c:v>23.099105999999999</c:v>
                </c:pt>
                <c:pt idx="1">
                  <c:v>26.123816000000001</c:v>
                </c:pt>
                <c:pt idx="2">
                  <c:v>25.316092000000001</c:v>
                </c:pt>
                <c:pt idx="3">
                  <c:v>26.265772999999999</c:v>
                </c:pt>
                <c:pt idx="4">
                  <c:v>26.348279000000002</c:v>
                </c:pt>
                <c:pt idx="5">
                  <c:v>28.224409000000001</c:v>
                </c:pt>
                <c:pt idx="6">
                  <c:v>30.647482</c:v>
                </c:pt>
                <c:pt idx="7">
                  <c:v>37.707999999999998</c:v>
                </c:pt>
                <c:pt idx="8">
                  <c:v>33.136324999999999</c:v>
                </c:pt>
                <c:pt idx="9">
                  <c:v>31.609293999999998</c:v>
                </c:pt>
              </c:numCache>
            </c:numRef>
          </c:xVal>
          <c:yVal>
            <c:numRef>
              <c:f>Sheet1!$S$23:$S$32</c:f>
              <c:numCache>
                <c:formatCode>General</c:formatCode>
                <c:ptCount val="10"/>
                <c:pt idx="0">
                  <c:v>23.92285</c:v>
                </c:pt>
                <c:pt idx="1">
                  <c:v>24.447990000000001</c:v>
                </c:pt>
                <c:pt idx="2">
                  <c:v>24.973130000000001</c:v>
                </c:pt>
                <c:pt idx="3">
                  <c:v>25.498270000000002</c:v>
                </c:pt>
                <c:pt idx="4">
                  <c:v>26.023409999999998</c:v>
                </c:pt>
                <c:pt idx="5">
                  <c:v>26.548549999999999</c:v>
                </c:pt>
                <c:pt idx="6">
                  <c:v>27.073689999999999</c:v>
                </c:pt>
                <c:pt idx="7">
                  <c:v>27.59883</c:v>
                </c:pt>
                <c:pt idx="8">
                  <c:v>28.12397</c:v>
                </c:pt>
                <c:pt idx="9">
                  <c:v>28.649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0AD-46E1-BE89-077D29C07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88253279"/>
        <c:axId val="921276639"/>
      </c:scatterChart>
      <c:valAx>
        <c:axId val="1088253279"/>
        <c:scaling>
          <c:orientation val="minMax"/>
          <c:min val="2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t-EE"/>
                  <a:t>Forecasted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21276639"/>
        <c:crosses val="autoZero"/>
        <c:crossBetween val="midCat"/>
      </c:valAx>
      <c:valAx>
        <c:axId val="921276639"/>
        <c:scaling>
          <c:orientation val="minMax"/>
          <c:min val="2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t-EE"/>
                  <a:t>Observed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8825327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9F1A2E-7D75-4829-807D-3A0669D147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BC4AB03-7E65-495B-BABB-0B8B2C6864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9582B5-EDE7-4299-AF88-3EE007CE16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26DA7E-28AF-4B8A-A7BA-F5E686F56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344046-91FB-48BF-9749-C1961968BE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67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35FF3-F031-432C-AC78-92BDD9402B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1387B3-AC83-4788-B64A-2683804709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2C742A-B59F-4897-A106-DE10183AA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4F6503-C8AD-47ED-AAD3-8F6DD4E3C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E26394-E7A4-4A62-931B-6C0F0E997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4603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A1EBD59-4D11-4FEF-B285-5D6669DE3E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B1BE-50D7-4756-B50A-E2BB7D8F4B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7BAF63-EDC3-4D07-BA2B-E43988E85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C3057-261C-4CB0-B8D6-41EA651E2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546679-FF40-4F4B-92A4-7B2DFC014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663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E7194-66F0-442B-AE4E-ABD3F2E600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C7FD90-17D8-4792-9D6F-1321EA6C93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240842-6311-467A-BD23-F549AAF4A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57C1CC-76BB-4868-B041-39B6087AA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0D53E8-1154-470C-AD48-5385A599D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560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98BFE-5759-4F29-96CF-39640875FF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6813AF-E1BA-4747-9098-E899AFAE11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E2EAED-7D03-4C72-8D90-074A158281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D1801-E88E-4DB7-8CD0-43F58192C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A34C4F-CD6B-4DCD-97CC-B583F640CC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146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EDE6C2-5309-40C8-A112-65751AC173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58DE1F-2E3D-4C35-B86D-9E793D135C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69D9F0-9121-47B4-8F71-F137074D1C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1A9B77-D43B-4B57-8BDF-90EC0D5BA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2BF3CB-EAEE-48C9-88B9-1121D12A0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FE716C-FB39-47EB-9515-19F7B48FE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477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DB0995-C7AC-4CED-8566-435545381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0A9DBF-387F-4AEB-B8A0-23BB93738D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6FBD8A-422B-4774-AA66-F9714A472B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416EF5-8975-492F-8CE1-6C35C6C233E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B1FA34-BDCC-41D3-9828-7B1C8147DE7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7077B8-DF92-41D4-8DEB-3FEC6894B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E9D98D-0685-4742-AD3D-A7C685D611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6FBE45-8C11-40CC-B805-0AF37D94B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60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F3D3BA-FAFC-4F1B-BA32-6430D7D3F0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3C1C61-BEA6-496F-9A51-5A24AFEDC6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96AB3D-7E78-4F78-BED3-21B91A243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C202661-BD2C-4D15-A878-4A2831BC5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3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5D62D0-3549-4BF1-8342-EF7880EE4A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C49A88-5103-4D16-B15E-741AE81B4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48A5C1-3DD9-4D8B-A1C7-068892433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46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D77563-7E68-4142-A152-33D571ADEB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1F6C93-1E39-4FEB-B8B2-63E048AA6D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FDC44B3-8FEB-486E-B1A6-90445AF40D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A2DBF5-69F5-4A2B-AF6B-CEA5C904E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F7AF9F-4127-4026-87AB-7F83C0B7BA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280A29-0ABF-4A1B-8AC6-7B74B93A5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765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CA03C-5BAC-4167-B8A3-BF53294DAA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719B60-426F-44DF-94C0-3958E779A8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7D2C8D-768E-4356-ADAD-66C4DFF124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B3CE0-796F-4EAE-AE4F-7AD118B4B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6E8ECB-C47A-445D-9766-C0359265E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E18EBD-BA12-415B-826B-C2DF61DD3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30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CEB271-7468-457D-849C-E9FDADBDC1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9731C-74FE-4CDE-A5E8-1AF4119EB3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EEB534-6714-47D6-A59D-A4EEA9DCAC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6DE52C-DC78-4CA8-AB37-4A11FA2EB84E}" type="datetimeFigureOut">
              <a:rPr lang="en-US" smtClean="0"/>
              <a:t>5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5323F5-5CAA-46F9-822F-4221B20D5D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568729-84F8-4146-8B52-1FDD44074E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0BFD3-AD02-4A78-BC63-E89F3BF4C3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057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28BB44A9-25EF-4F71-96EE-6889BC7F64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2940322"/>
              </p:ext>
            </p:extLst>
          </p:nvPr>
        </p:nvGraphicFramePr>
        <p:xfrm>
          <a:off x="496347" y="312490"/>
          <a:ext cx="5166221" cy="3116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193EE132-A2ED-4528-934D-8312F44F1AF0}"/>
              </a:ext>
            </a:extLst>
          </p:cNvPr>
          <p:cNvCxnSpPr/>
          <p:nvPr/>
        </p:nvCxnSpPr>
        <p:spPr>
          <a:xfrm>
            <a:off x="1635853" y="3489820"/>
            <a:ext cx="2348918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B03453B2-0E28-48AE-B605-9FA6BB7B40BB}"/>
              </a:ext>
            </a:extLst>
          </p:cNvPr>
          <p:cNvCxnSpPr>
            <a:cxnSpLocks/>
          </p:cNvCxnSpPr>
          <p:nvPr/>
        </p:nvCxnSpPr>
        <p:spPr>
          <a:xfrm>
            <a:off x="3984771" y="3489820"/>
            <a:ext cx="1216403" cy="0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A7B8161-1FEE-431D-9AD5-06A362997998}"/>
              </a:ext>
            </a:extLst>
          </p:cNvPr>
          <p:cNvSpPr txBox="1"/>
          <p:nvPr/>
        </p:nvSpPr>
        <p:spPr>
          <a:xfrm>
            <a:off x="2178616" y="3489606"/>
            <a:ext cx="9878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 err="1"/>
              <a:t>Training</a:t>
            </a:r>
            <a:r>
              <a:rPr lang="et-EE" sz="1200" dirty="0"/>
              <a:t> </a:t>
            </a:r>
            <a:r>
              <a:rPr lang="et-EE" sz="1200" dirty="0" err="1"/>
              <a:t>data</a:t>
            </a:r>
            <a:endParaRPr lang="en-US" sz="12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02F7360-C910-4A8D-88DA-A96F96E2CE0C}"/>
              </a:ext>
            </a:extLst>
          </p:cNvPr>
          <p:cNvSpPr txBox="1"/>
          <p:nvPr/>
        </p:nvSpPr>
        <p:spPr>
          <a:xfrm>
            <a:off x="4052023" y="3489606"/>
            <a:ext cx="11439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sz="1200" dirty="0" err="1"/>
              <a:t>Evaluation</a:t>
            </a:r>
            <a:r>
              <a:rPr lang="et-EE" sz="1200" dirty="0"/>
              <a:t> </a:t>
            </a:r>
            <a:r>
              <a:rPr lang="et-EE" sz="1200" dirty="0" err="1"/>
              <a:t>data</a:t>
            </a:r>
            <a:endParaRPr lang="en-US" sz="1200" dirty="0"/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4FDE4797-EB30-4EDD-828B-0BB2687727BA}"/>
              </a:ext>
            </a:extLst>
          </p:cNvPr>
          <p:cNvCxnSpPr/>
          <p:nvPr/>
        </p:nvCxnSpPr>
        <p:spPr>
          <a:xfrm>
            <a:off x="5617830" y="1711354"/>
            <a:ext cx="897623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5D734EDC-6A4F-493D-A3AF-2D26ABA14118}"/>
              </a:ext>
            </a:extLst>
          </p:cNvPr>
          <p:cNvCxnSpPr/>
          <p:nvPr/>
        </p:nvCxnSpPr>
        <p:spPr>
          <a:xfrm>
            <a:off x="5631811" y="2123813"/>
            <a:ext cx="897623" cy="0"/>
          </a:xfrm>
          <a:prstGeom prst="line">
            <a:avLst/>
          </a:prstGeom>
          <a:ln w="28575"/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6C7B4CB-DF19-4E81-8AB4-64FC21D793B6}"/>
              </a:ext>
            </a:extLst>
          </p:cNvPr>
          <p:cNvSpPr txBox="1"/>
          <p:nvPr/>
        </p:nvSpPr>
        <p:spPr>
          <a:xfrm>
            <a:off x="6529434" y="1526688"/>
            <a:ext cx="8306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/>
              <a:t>ARIMA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F247637-CF5A-4A38-8113-F09846ECB0C1}"/>
              </a:ext>
            </a:extLst>
          </p:cNvPr>
          <p:cNvSpPr txBox="1"/>
          <p:nvPr/>
        </p:nvSpPr>
        <p:spPr>
          <a:xfrm>
            <a:off x="6543415" y="1937640"/>
            <a:ext cx="2343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Exponential</a:t>
            </a:r>
            <a:r>
              <a:rPr lang="et-EE" dirty="0"/>
              <a:t> </a:t>
            </a:r>
            <a:r>
              <a:rPr lang="et-EE" dirty="0" err="1"/>
              <a:t>smoothing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18E4D9D-6D6B-448A-AF90-8EE2FF2B2A55}"/>
              </a:ext>
            </a:extLst>
          </p:cNvPr>
          <p:cNvSpPr txBox="1"/>
          <p:nvPr/>
        </p:nvSpPr>
        <p:spPr>
          <a:xfrm rot="16200000">
            <a:off x="-593698" y="1686079"/>
            <a:ext cx="2152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Mean</a:t>
            </a:r>
            <a:r>
              <a:rPr lang="et-EE" dirty="0"/>
              <a:t> </a:t>
            </a:r>
            <a:r>
              <a:rPr lang="et-EE" dirty="0" err="1"/>
              <a:t>defoliation</a:t>
            </a:r>
            <a:r>
              <a:rPr lang="et-EE" dirty="0"/>
              <a:t> [%]</a:t>
            </a:r>
            <a:endParaRPr lang="en-US" dirty="0"/>
          </a:p>
        </p:txBody>
      </p:sp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D0BA8C1E-E312-4FFF-AC8B-9CA2F5F7AD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3127481"/>
              </p:ext>
            </p:extLst>
          </p:nvPr>
        </p:nvGraphicFramePr>
        <p:xfrm>
          <a:off x="880451" y="391975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D0BA8C1E-E312-4FFF-AC8B-9CA2F5F7AD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9471376"/>
              </p:ext>
            </p:extLst>
          </p:nvPr>
        </p:nvGraphicFramePr>
        <p:xfrm>
          <a:off x="6267973" y="391975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>
            <a:extLst>
              <a:ext uri="{FF2B5EF4-FFF2-40B4-BE49-F238E27FC236}">
                <a16:creationId xmlns:a16="http://schemas.microsoft.com/office/drawing/2014/main" id="{2C9EBBD5-1722-4973-B2C5-DBBF9A446263}"/>
              </a:ext>
            </a:extLst>
          </p:cNvPr>
          <p:cNvSpPr txBox="1"/>
          <p:nvPr/>
        </p:nvSpPr>
        <p:spPr>
          <a:xfrm>
            <a:off x="2046268" y="3735090"/>
            <a:ext cx="2678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/>
              <a:t>ARIMA (r=0.82, MSE=6.59)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D8336E-A98D-4A26-9847-E57125140982}"/>
              </a:ext>
            </a:extLst>
          </p:cNvPr>
          <p:cNvSpPr txBox="1"/>
          <p:nvPr/>
        </p:nvSpPr>
        <p:spPr>
          <a:xfrm>
            <a:off x="6648313" y="3766605"/>
            <a:ext cx="41916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t-EE" dirty="0" err="1"/>
              <a:t>Exponential</a:t>
            </a:r>
            <a:r>
              <a:rPr lang="et-EE" dirty="0"/>
              <a:t> </a:t>
            </a:r>
            <a:r>
              <a:rPr lang="et-EE" dirty="0" err="1"/>
              <a:t>smoothing</a:t>
            </a:r>
            <a:r>
              <a:rPr lang="et-EE" dirty="0"/>
              <a:t> (r=0.85, MSE=15.9)</a:t>
            </a:r>
            <a:endParaRPr lang="en-US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C5A23E0C-C1C9-4FC3-95E1-C1EE7A451418}"/>
              </a:ext>
            </a:extLst>
          </p:cNvPr>
          <p:cNvCxnSpPr/>
          <p:nvPr/>
        </p:nvCxnSpPr>
        <p:spPr>
          <a:xfrm>
            <a:off x="5631811" y="1293303"/>
            <a:ext cx="897623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5929B33E-BB15-4AC2-BFAC-C390626F1B9C}"/>
              </a:ext>
            </a:extLst>
          </p:cNvPr>
          <p:cNvSpPr txBox="1"/>
          <p:nvPr/>
        </p:nvSpPr>
        <p:spPr>
          <a:xfrm>
            <a:off x="6515453" y="1087771"/>
            <a:ext cx="108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bserved</a:t>
            </a:r>
          </a:p>
        </p:txBody>
      </p:sp>
    </p:spTree>
    <p:extLst>
      <p:ext uri="{BB962C8B-B14F-4D97-AF65-F5344CB8AC3E}">
        <p14:creationId xmlns:p14="http://schemas.microsoft.com/office/powerpoint/2010/main" val="1561357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6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 Peter George</dc:creator>
  <cp:lastModifiedBy>Jan Peter George</cp:lastModifiedBy>
  <cp:revision>2</cp:revision>
  <dcterms:created xsi:type="dcterms:W3CDTF">2021-05-20T13:23:03Z</dcterms:created>
  <dcterms:modified xsi:type="dcterms:W3CDTF">2021-05-20T18:27:19Z</dcterms:modified>
</cp:coreProperties>
</file>